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4"/>
  </p:sldMasterIdLst>
  <p:notesMasterIdLst>
    <p:notesMasterId r:id="rId6"/>
  </p:notesMasterIdLst>
  <p:sldIdLst>
    <p:sldId id="256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6113"/>
    <p:restoredTop sz="79660"/>
  </p:normalViewPr>
  <p:slideViewPr>
    <p:cSldViewPr snapToGrid="0">
      <p:cViewPr varScale="1">
        <p:scale>
          <a:sx n="59" d="100"/>
          <a:sy n="59" d="100"/>
        </p:scale>
        <p:origin x="72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492BF62-3E73-904A-A031-734C1CD116F9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42EEF5A-A0FE-5742-86FE-F1883385BC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60890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/>
            <a:r>
              <a:rPr lang="en-US" sz="1200" b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ocalization of tight junction (TJ) proteins and TEER measurements in immortalized hCMEC/D3 and hiPSC-derived BMECs.</a:t>
            </a:r>
            <a:r>
              <a:rPr lang="en-US" sz="1200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b="1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)</a:t>
            </a:r>
            <a:r>
              <a:rPr lang="en-US" sz="1200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EER measurements from hCMEC/D3 &amp; hiPSC-derived BMECs. </a:t>
            </a:r>
            <a:r>
              <a:rPr lang="en-US" sz="1200" b="1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B)</a:t>
            </a:r>
            <a:r>
              <a:rPr lang="en-US" sz="1200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ZO-1 and occludin localization on hCMEC/D3 cells. </a:t>
            </a:r>
            <a:r>
              <a:rPr lang="en-US" sz="1200" b="1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C) </a:t>
            </a:r>
            <a:r>
              <a:rPr lang="en-US" sz="1200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ZO-1 and occludin localization on hiPSC-derived BMECs</a:t>
            </a:r>
            <a:r>
              <a:rPr lang="en-US" sz="1200" b="1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D) </a:t>
            </a:r>
            <a:r>
              <a:rPr lang="en-US" sz="1200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LUT-1 localization in hiPSC-derived BMECs. Immunofluorescence labeled as ZO-1, occludin, and GLUT-1 (green), nucleus (blue). Scale bar=100 µm.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42EEF5A-A0FE-5742-86FE-F1883385BC8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596195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1F2EE30F-AA44-F437-5ED1-F2DF02EE04A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63151F4C-A818-33E8-2C59-4D4E0F73778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574E16E5-3449-BB40-D029-C7BF539CCE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0FF877-8F42-E44E-843E-DF5B614D9BE1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6F94B495-14FE-D9D5-A97E-2F31E2F35E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BF186251-19F3-BD55-98DC-BFDAA1722D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A2C11-376F-204B-A116-DB6ADFC055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99947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E62E86D-37C4-E200-13FF-9F8B72608D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88AD8C78-5C6E-2392-9E23-67D298BF5F4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30F16B1C-514D-A2BC-EF4E-BF3E8EE4F8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0FF877-8F42-E44E-843E-DF5B614D9BE1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29841BFB-DE16-8B3D-4003-754F50039C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FBCA8B9D-F583-9C35-205F-29EBF34CB0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A2C11-376F-204B-A116-DB6ADFC055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39768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19D5281D-201C-61E4-87E2-7A39F424055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72202CCF-823F-347F-A6ED-D0992EFBF8C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13A3B16C-DC22-11FC-7357-60C3C85DB9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0FF877-8F42-E44E-843E-DF5B614D9BE1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F0C46659-9E57-9925-C9ED-4B6AB5D775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8CB41385-CD42-C0E3-9702-5CC3C77C96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A2C11-376F-204B-A116-DB6ADFC055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28883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73F5E039-8DE4-D250-8DB3-E5B18498A3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E5396045-6ABB-B9E8-90F1-9900D0FCBC5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6188ACF6-3517-5923-6C37-DC97E935E8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0FF877-8F42-E44E-843E-DF5B614D9BE1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C531EB5B-49B0-9563-806A-D17F0D0FA3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FF1768BF-B1E6-A5F9-FF40-BEA12518B4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A2C11-376F-204B-A116-DB6ADFC055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85020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69157FA8-13DA-631B-D820-DE521CF47C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96CE493B-1830-CC50-378F-0F3403F351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A19AA5E6-5DA1-054B-67A2-E3641E788F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0FF877-8F42-E44E-843E-DF5B614D9BE1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58E3CCED-CB16-3814-629C-19F3F0BC75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1329914F-9BC9-2904-663C-01C4AF3D68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A2C11-376F-204B-A116-DB6ADFC055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11473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ACCF657-7A4C-446A-729F-F042BA0F2F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F4DF8C51-5CBA-108A-9412-CF34D0838C3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C84E380A-E449-2D5C-B831-86A47E07326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EBCEFEC2-54B0-83CE-773B-BE6B302A83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0FF877-8F42-E44E-843E-DF5B614D9BE1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5DC8D5FE-7656-3704-0A63-B23B949EFA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2335165B-C7DE-1BDB-7E32-6AE49BDA12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A2C11-376F-204B-A116-DB6ADFC055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0030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DFAED2D-7CA4-949F-03A8-058F00A6AC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E95BDBAB-E9DD-E15F-4246-6F4B58D7EB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539F6F27-67B6-B961-301B-9149C5EEB6E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04DA8F2D-F1D4-4ED5-51C2-2DEC488812B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6D9E92D2-8086-23D3-9080-46862308B11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3B120ECE-7863-8A07-C175-B79013BBBC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0FF877-8F42-E44E-843E-DF5B614D9BE1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9D43120B-C553-4E4C-562B-5D43F9516E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F01D7DF9-BDB0-C2C9-112D-8438015035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A2C11-376F-204B-A116-DB6ADFC055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36209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750C314-5279-D7EB-2A93-CF6973C69D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82E2D16B-38ED-D29A-16EF-4394E26BA5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0FF877-8F42-E44E-843E-DF5B614D9BE1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5267B79D-62EE-AAF2-A06C-6B2025A5F9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54FA872A-6081-30EA-6132-9196D2EE40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A2C11-376F-204B-A116-DB6ADFC055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75409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1248C01B-6D08-0C7D-F182-A5F8D52888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0FF877-8F42-E44E-843E-DF5B614D9BE1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3406354F-DE4E-8991-06B7-119283FADC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183B550D-E8D4-C498-0AD0-1932512C58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A2C11-376F-204B-A116-DB6ADFC055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60488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CA6EC3F-AA78-A462-C3E3-A714C5CE59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9F7319BE-1EEC-3AA4-2465-6ED51399A4C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72B0EBEA-8429-1775-EAD9-D037BA52F0A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E83922F0-F68C-2513-71DB-27A327F03C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0FF877-8F42-E44E-843E-DF5B614D9BE1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682E83C2-77A8-287E-757F-F9BB1C5765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BCBC902D-AC5B-3CFB-CE5F-ACDD031D76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A2C11-376F-204B-A116-DB6ADFC055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86347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F449EE45-8C58-7C6B-52C8-BC6771ABD8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80163889-090A-2BC3-3C97-77E906C92F9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EAE9E5F9-D48A-BBBE-C860-3E49D2DC1A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FC916391-99A4-90FA-7C9E-1DE67F56B9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0FF877-8F42-E44E-843E-DF5B614D9BE1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5F73E0A9-A2E8-307D-D35B-A01D52C017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237DD83C-1EF4-A6A3-36D8-4A93C33106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A2C11-376F-204B-A116-DB6ADFC055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66473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9677B4C6-43D5-22FF-CDEB-BD8C63975B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F8E7BBF8-DF01-EAAD-08BD-AF65B02908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E8065F67-115B-AA1B-126A-EB1096A975C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B0FF877-8F42-E44E-843E-DF5B614D9BE1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586170AC-5963-A333-27DA-FC6DDEABB02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4BD46D3E-E2D4-FE7A-F6B5-B93CB83D9E4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41A2C11-376F-204B-A116-DB6ADFC055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93688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60E18501-F9F3-87E2-D077-BCC92C35C92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60854" y="204755"/>
            <a:ext cx="7772400" cy="446310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647A1968-38EB-BFE8-426F-E6630535CBDC}"/>
              </a:ext>
            </a:extLst>
          </p:cNvPr>
          <p:cNvSpPr txBox="1"/>
          <p:nvPr/>
        </p:nvSpPr>
        <p:spPr>
          <a:xfrm>
            <a:off x="2132174" y="4919850"/>
            <a:ext cx="7601080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0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</a:t>
            </a:r>
            <a:r>
              <a:rPr lang="en-US" sz="10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r>
              <a:rPr lang="en-US" sz="1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0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ocalization of tight junction (TJ) proteins and TEER measurements in immortalized hCMEC/D3 and hiPSC-derived BMECs.</a:t>
            </a:r>
            <a:r>
              <a:rPr lang="en-US" sz="1000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000" b="1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)</a:t>
            </a:r>
            <a:r>
              <a:rPr lang="en-US" sz="1000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EER measurements from hCMEC/D3 &amp; hiPSC-derived BMECs. </a:t>
            </a:r>
            <a:r>
              <a:rPr lang="en-US" sz="1000" b="1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B)</a:t>
            </a:r>
            <a:r>
              <a:rPr lang="en-US" sz="1000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ZO-1 and occludin localization on hCMEC/D3 cells. </a:t>
            </a:r>
            <a:r>
              <a:rPr lang="en-US" sz="1000" b="1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C) </a:t>
            </a:r>
            <a:r>
              <a:rPr lang="en-US" sz="1000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ZO-1 and </a:t>
            </a:r>
            <a:r>
              <a:rPr lang="en-US" sz="1000" kern="50" spc="-15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ccludin</a:t>
            </a:r>
            <a:r>
              <a:rPr lang="en-US" sz="1000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localization on </a:t>
            </a:r>
            <a:r>
              <a:rPr lang="en-US" sz="1000" kern="50" spc="-15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iPSC</a:t>
            </a:r>
            <a:r>
              <a:rPr lang="en-US" sz="1000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derived BMECs</a:t>
            </a:r>
            <a:r>
              <a:rPr lang="en-US" sz="1000" b="1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D) </a:t>
            </a:r>
            <a:r>
              <a:rPr lang="en-US" sz="1000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LUT-1 localization in </a:t>
            </a:r>
            <a:r>
              <a:rPr lang="en-US" sz="1000" kern="50" spc="-15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iPSC</a:t>
            </a:r>
            <a:r>
              <a:rPr lang="en-US" sz="1000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derived BMECs. Immunofluorescence labeled as ZO-1, occludin, and GLUT-1 (green), nucleus (blue). Scale bar=100 µm.</a:t>
            </a:r>
            <a:endParaRPr lang="en-US" sz="10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586179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46F83623FE0101439BF9CBCA708448C2" ma:contentTypeVersion="14" ma:contentTypeDescription="Create a new document." ma:contentTypeScope="" ma:versionID="43435aca2c006b86cb5a1b4b69da5887">
  <xsd:schema xmlns:xsd="http://www.w3.org/2001/XMLSchema" xmlns:xs="http://www.w3.org/2001/XMLSchema" xmlns:p="http://schemas.microsoft.com/office/2006/metadata/properties" xmlns:ns2="88a897e8-d4da-4754-b76c-471f0d488363" xmlns:ns3="9a2030ed-2c9c-4ecf-96df-48ffd2037682" targetNamespace="http://schemas.microsoft.com/office/2006/metadata/properties" ma:root="true" ma:fieldsID="8e3ea8bdce2d7a53ced3a228efd8bbf6" ns2:_="" ns3:_="">
    <xsd:import namespace="88a897e8-d4da-4754-b76c-471f0d488363"/>
    <xsd:import namespace="9a2030ed-2c9c-4ecf-96df-48ffd2037682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3:SharedWithUsers" minOccurs="0"/>
                <xsd:element ref="ns3:SharedWithDetails" minOccurs="0"/>
                <xsd:element ref="ns2:lcf76f155ced4ddcb4097134ff3c332f" minOccurs="0"/>
                <xsd:element ref="ns3:TaxCatchAll" minOccurs="0"/>
                <xsd:element ref="ns2:MediaServiceObjectDetectorVersion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MediaServiceSearchProperties" minOccurs="0"/>
                <xsd:element ref="ns2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8a897e8-d4da-4754-b76c-471f0d488363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lcf76f155ced4ddcb4097134ff3c332f" ma:index="13" nillable="true" ma:taxonomy="true" ma:internalName="lcf76f155ced4ddcb4097134ff3c332f" ma:taxonomyFieldName="MediaServiceImageTags" ma:displayName="Image Tags" ma:readOnly="false" ma:fieldId="{5cf76f15-5ced-4ddc-b409-7134ff3c332f}" ma:taxonomyMulti="true" ma:sspId="0eec0a79-46cb-4568-9b1b-2d720bd3207c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bjectDetectorVersions" ma:index="15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9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SearchProperties" ma:index="20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Location" ma:index="21" nillable="true" ma:displayName="Location" ma:indexed="true" ma:internalName="MediaServiceLocatio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a2030ed-2c9c-4ecf-96df-48ffd2037682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14" nillable="true" ma:displayName="Taxonomy Catch All Column" ma:hidden="true" ma:list="{d587f133-08ee-41ab-81b8-7455cffb4ef8}" ma:internalName="TaxCatchAll" ma:showField="CatchAllData" ma:web="9a2030ed-2c9c-4ecf-96df-48ffd2037682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88a897e8-d4da-4754-b76c-471f0d488363">
      <Terms xmlns="http://schemas.microsoft.com/office/infopath/2007/PartnerControls"/>
    </lcf76f155ced4ddcb4097134ff3c332f>
    <TaxCatchAll xmlns="9a2030ed-2c9c-4ecf-96df-48ffd2037682" xsi:nil="true"/>
  </documentManagement>
</p:properties>
</file>

<file path=customXml/itemProps1.xml><?xml version="1.0" encoding="utf-8"?>
<ds:datastoreItem xmlns:ds="http://schemas.openxmlformats.org/officeDocument/2006/customXml" ds:itemID="{BAD0DFC9-EFCD-4416-99AC-1E4D46252872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DA228A03-192E-4EAB-B139-CCACE0475E81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88a897e8-d4da-4754-b76c-471f0d488363"/>
    <ds:schemaRef ds:uri="9a2030ed-2c9c-4ecf-96df-48ffd2037682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C0D813FC-2A2A-40D1-B1C7-081139E2166D}">
  <ds:schemaRefs>
    <ds:schemaRef ds:uri="http://schemas.microsoft.com/office/2006/metadata/properties"/>
    <ds:schemaRef ds:uri="http://schemas.microsoft.com/office/infopath/2007/PartnerControls"/>
    <ds:schemaRef ds:uri="88a897e8-d4da-4754-b76c-471f0d488363"/>
    <ds:schemaRef ds:uri="9a2030ed-2c9c-4ecf-96df-48ffd2037682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65</Words>
  <Application>Microsoft Office PowerPoint</Application>
  <PresentationFormat>Widescreen</PresentationFormat>
  <Paragraphs>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opinadhan, Adnan</dc:creator>
  <cp:lastModifiedBy>Maria Flora V.</cp:lastModifiedBy>
  <cp:revision>3</cp:revision>
  <dcterms:created xsi:type="dcterms:W3CDTF">2024-04-11T16:49:26Z</dcterms:created>
  <dcterms:modified xsi:type="dcterms:W3CDTF">2024-04-20T11:56:3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46F83623FE0101439BF9CBCA708448C2</vt:lpwstr>
  </property>
</Properties>
</file>